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70" d="100"/>
          <a:sy n="70" d="100"/>
        </p:scale>
        <p:origin x="2251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37759856142499"/>
          <c:y val="8.1515151515151499E-2"/>
          <c:w val="0.74048496732026126"/>
          <c:h val="0.82131507993318997"/>
        </c:manualLayout>
      </c:layout>
      <c:lineChart>
        <c:grouping val="standard"/>
        <c:varyColors val="0"/>
        <c:ser>
          <c:idx val="1"/>
          <c:order val="0"/>
          <c:tx>
            <c:strRef>
              <c:f>Sheet1!$A$29</c:f>
              <c:strCache>
                <c:ptCount val="1"/>
                <c:pt idx="0">
                  <c:v>Ctrl_1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29:$P$29</c:f>
              <c:numCache>
                <c:formatCode>General</c:formatCode>
                <c:ptCount val="10"/>
                <c:pt idx="0">
                  <c:v>99.901984000000013</c:v>
                </c:pt>
                <c:pt idx="1">
                  <c:v>495.196009</c:v>
                </c:pt>
                <c:pt idx="2">
                  <c:v>682.58456999999987</c:v>
                </c:pt>
                <c:pt idx="3">
                  <c:v>1754.4234150000002</c:v>
                </c:pt>
                <c:pt idx="4">
                  <c:v>2921.4127675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E4A-4E5B-AFF0-70544CA074E2}"/>
            </c:ext>
          </c:extLst>
        </c:ser>
        <c:ser>
          <c:idx val="2"/>
          <c:order val="1"/>
          <c:tx>
            <c:strRef>
              <c:f>Sheet1!$A$30</c:f>
              <c:strCache>
                <c:ptCount val="1"/>
                <c:pt idx="0">
                  <c:v>Ctrl_2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0:$P$30</c:f>
              <c:numCache>
                <c:formatCode>General</c:formatCode>
                <c:ptCount val="10"/>
                <c:pt idx="0">
                  <c:v>32.094415999999995</c:v>
                </c:pt>
                <c:pt idx="1">
                  <c:v>52.032384000000008</c:v>
                </c:pt>
                <c:pt idx="2">
                  <c:v>549.56723199999999</c:v>
                </c:pt>
                <c:pt idx="3">
                  <c:v>1223.0004375000003</c:v>
                </c:pt>
                <c:pt idx="4">
                  <c:v>2044.93464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E4A-4E5B-AFF0-70544CA074E2}"/>
            </c:ext>
          </c:extLst>
        </c:ser>
        <c:ser>
          <c:idx val="3"/>
          <c:order val="2"/>
          <c:tx>
            <c:strRef>
              <c:f>Sheet1!$A$31</c:f>
              <c:strCache>
                <c:ptCount val="1"/>
                <c:pt idx="0">
                  <c:v>Ctrl_3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1:$P$31</c:f>
              <c:numCache>
                <c:formatCode>General</c:formatCode>
                <c:ptCount val="10"/>
                <c:pt idx="0">
                  <c:v>56.296908000000009</c:v>
                </c:pt>
                <c:pt idx="1">
                  <c:v>546.161247</c:v>
                </c:pt>
                <c:pt idx="2">
                  <c:v>802.57989599999985</c:v>
                </c:pt>
                <c:pt idx="3">
                  <c:v>1215.5062500000001</c:v>
                </c:pt>
                <c:pt idx="4">
                  <c:v>2681.2923994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E4A-4E5B-AFF0-70544CA074E2}"/>
            </c:ext>
          </c:extLst>
        </c:ser>
        <c:ser>
          <c:idx val="5"/>
          <c:order val="3"/>
          <c:tx>
            <c:strRef>
              <c:f>Sheet1!$A$34</c:f>
              <c:strCache>
                <c:ptCount val="1"/>
                <c:pt idx="0">
                  <c:v>PD-1_1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4:$P$34</c:f>
              <c:numCache>
                <c:formatCode>General</c:formatCode>
                <c:ptCount val="10"/>
                <c:pt idx="0">
                  <c:v>42.980080000000001</c:v>
                </c:pt>
                <c:pt idx="1">
                  <c:v>193.11462400000002</c:v>
                </c:pt>
                <c:pt idx="2">
                  <c:v>815.8547249999998</c:v>
                </c:pt>
                <c:pt idx="3">
                  <c:v>1427.0158080000003</c:v>
                </c:pt>
                <c:pt idx="4">
                  <c:v>1749.958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E4A-4E5B-AFF0-70544CA074E2}"/>
            </c:ext>
          </c:extLst>
        </c:ser>
        <c:ser>
          <c:idx val="6"/>
          <c:order val="4"/>
          <c:tx>
            <c:strRef>
              <c:f>Sheet1!$A$35</c:f>
              <c:strCache>
                <c:ptCount val="1"/>
                <c:pt idx="0">
                  <c:v>PD-1_2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5:$P$35</c:f>
              <c:numCache>
                <c:formatCode>General</c:formatCode>
                <c:ptCount val="10"/>
                <c:pt idx="0">
                  <c:v>80.611199999999997</c:v>
                </c:pt>
                <c:pt idx="1">
                  <c:v>353.44319399999995</c:v>
                </c:pt>
                <c:pt idx="2">
                  <c:v>557.77250000000004</c:v>
                </c:pt>
                <c:pt idx="3">
                  <c:v>1021.7525245</c:v>
                </c:pt>
                <c:pt idx="4">
                  <c:v>1856.825</c:v>
                </c:pt>
                <c:pt idx="5">
                  <c:v>3999.0000625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E4A-4E5B-AFF0-70544CA074E2}"/>
            </c:ext>
          </c:extLst>
        </c:ser>
        <c:ser>
          <c:idx val="7"/>
          <c:order val="5"/>
          <c:tx>
            <c:strRef>
              <c:f>Sheet1!$A$36</c:f>
              <c:strCache>
                <c:ptCount val="1"/>
                <c:pt idx="0">
                  <c:v>PD-1_3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6:$P$36</c:f>
              <c:numCache>
                <c:formatCode>General</c:formatCode>
                <c:ptCount val="10"/>
                <c:pt idx="0">
                  <c:v>42.232139999999994</c:v>
                </c:pt>
                <c:pt idx="1">
                  <c:v>127.37331199999998</c:v>
                </c:pt>
                <c:pt idx="2">
                  <c:v>302.25238400000001</c:v>
                </c:pt>
                <c:pt idx="3">
                  <c:v>707.53037849999998</c:v>
                </c:pt>
                <c:pt idx="4">
                  <c:v>1213.8057785000001</c:v>
                </c:pt>
                <c:pt idx="5">
                  <c:v>2753.979103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E4A-4E5B-AFF0-70544CA074E2}"/>
            </c:ext>
          </c:extLst>
        </c:ser>
        <c:ser>
          <c:idx val="8"/>
          <c:order val="6"/>
          <c:tx>
            <c:strRef>
              <c:f>Sheet1!$A$37</c:f>
              <c:strCache>
                <c:ptCount val="1"/>
                <c:pt idx="0">
                  <c:v>PD-1_4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7:$P$37</c:f>
              <c:numCache>
                <c:formatCode>General</c:formatCode>
                <c:ptCount val="10"/>
                <c:pt idx="0">
                  <c:v>74.795991999999998</c:v>
                </c:pt>
                <c:pt idx="1">
                  <c:v>338.71294049999995</c:v>
                </c:pt>
                <c:pt idx="2">
                  <c:v>268.40729999999996</c:v>
                </c:pt>
                <c:pt idx="3">
                  <c:v>576.06948</c:v>
                </c:pt>
                <c:pt idx="4">
                  <c:v>490.14493200000004</c:v>
                </c:pt>
                <c:pt idx="5">
                  <c:v>1188.985392</c:v>
                </c:pt>
                <c:pt idx="6">
                  <c:v>3282.309887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E4A-4E5B-AFF0-70544CA074E2}"/>
            </c:ext>
          </c:extLst>
        </c:ser>
        <c:ser>
          <c:idx val="9"/>
          <c:order val="7"/>
          <c:tx>
            <c:strRef>
              <c:f>Sheet1!$A$38</c:f>
              <c:strCache>
                <c:ptCount val="1"/>
                <c:pt idx="0">
                  <c:v>PD-1_5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8:$P$38</c:f>
              <c:numCache>
                <c:formatCode>General</c:formatCode>
                <c:ptCount val="10"/>
                <c:pt idx="0">
                  <c:v>22.878876000000002</c:v>
                </c:pt>
                <c:pt idx="1">
                  <c:v>143.3567625</c:v>
                </c:pt>
                <c:pt idx="2">
                  <c:v>263.22750499999995</c:v>
                </c:pt>
                <c:pt idx="3">
                  <c:v>1447.3509750000001</c:v>
                </c:pt>
                <c:pt idx="4">
                  <c:v>818.37258350000002</c:v>
                </c:pt>
                <c:pt idx="5">
                  <c:v>1265.9409014999999</c:v>
                </c:pt>
                <c:pt idx="6">
                  <c:v>2337.4397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E4A-4E5B-AFF0-70544CA074E2}"/>
            </c:ext>
          </c:extLst>
        </c:ser>
        <c:ser>
          <c:idx val="10"/>
          <c:order val="8"/>
          <c:tx>
            <c:strRef>
              <c:f>Sheet1!$A$43</c:f>
              <c:strCache>
                <c:ptCount val="1"/>
                <c:pt idx="0">
                  <c:v>CRT_1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3:$P$43</c:f>
              <c:numCache>
                <c:formatCode>General</c:formatCode>
                <c:ptCount val="10"/>
                <c:pt idx="0">
                  <c:v>61.461562500000007</c:v>
                </c:pt>
                <c:pt idx="1">
                  <c:v>372.97679999999997</c:v>
                </c:pt>
                <c:pt idx="2">
                  <c:v>2457.241935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E4A-4E5B-AFF0-70544CA074E2}"/>
            </c:ext>
          </c:extLst>
        </c:ser>
        <c:ser>
          <c:idx val="11"/>
          <c:order val="9"/>
          <c:tx>
            <c:strRef>
              <c:f>Sheet1!$A$44</c:f>
              <c:strCache>
                <c:ptCount val="1"/>
                <c:pt idx="0">
                  <c:v>CRT_2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4:$P$44</c:f>
              <c:numCache>
                <c:formatCode>General</c:formatCode>
                <c:ptCount val="10"/>
                <c:pt idx="0">
                  <c:v>22.037651999999998</c:v>
                </c:pt>
                <c:pt idx="1">
                  <c:v>112.53937500000001</c:v>
                </c:pt>
                <c:pt idx="2">
                  <c:v>683.57266249999998</c:v>
                </c:pt>
                <c:pt idx="3">
                  <c:v>2775.699344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E4A-4E5B-AFF0-70544CA074E2}"/>
            </c:ext>
          </c:extLst>
        </c:ser>
        <c:ser>
          <c:idx val="12"/>
          <c:order val="10"/>
          <c:tx>
            <c:strRef>
              <c:f>Sheet1!$A$45</c:f>
              <c:strCache>
                <c:ptCount val="1"/>
                <c:pt idx="0">
                  <c:v>CRT_3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5:$P$45</c:f>
              <c:numCache>
                <c:formatCode>General</c:formatCode>
                <c:ptCount val="10"/>
                <c:pt idx="0">
                  <c:v>80.933029500000004</c:v>
                </c:pt>
                <c:pt idx="1">
                  <c:v>1603.4159280000001</c:v>
                </c:pt>
                <c:pt idx="2">
                  <c:v>4288.284714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E4A-4E5B-AFF0-70544CA074E2}"/>
            </c:ext>
          </c:extLst>
        </c:ser>
        <c:ser>
          <c:idx val="15"/>
          <c:order val="11"/>
          <c:tx>
            <c:strRef>
              <c:f>Sheet1!$A$48</c:f>
              <c:strCache>
                <c:ptCount val="1"/>
                <c:pt idx="0">
                  <c:v>PD-1-CRT_1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8:$P$48</c:f>
              <c:numCache>
                <c:formatCode>General</c:formatCode>
                <c:ptCount val="10"/>
                <c:pt idx="0">
                  <c:v>34.165151999999999</c:v>
                </c:pt>
                <c:pt idx="1">
                  <c:v>26.910400000000003</c:v>
                </c:pt>
                <c:pt idx="2">
                  <c:v>20.415537999999998</c:v>
                </c:pt>
                <c:pt idx="3">
                  <c:v>19.546875</c:v>
                </c:pt>
                <c:pt idx="4">
                  <c:v>13.561632000000001</c:v>
                </c:pt>
                <c:pt idx="5">
                  <c:v>50.118529500000001</c:v>
                </c:pt>
                <c:pt idx="6">
                  <c:v>144.42731550000002</c:v>
                </c:pt>
                <c:pt idx="7">
                  <c:v>144.42731550000002</c:v>
                </c:pt>
                <c:pt idx="8">
                  <c:v>166.218264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E4A-4E5B-AFF0-70544CA074E2}"/>
            </c:ext>
          </c:extLst>
        </c:ser>
        <c:ser>
          <c:idx val="16"/>
          <c:order val="12"/>
          <c:tx>
            <c:strRef>
              <c:f>Sheet1!$A$49</c:f>
              <c:strCache>
                <c:ptCount val="1"/>
                <c:pt idx="0">
                  <c:v>PD-1-CRT_2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9:$P$49</c:f>
              <c:numCache>
                <c:formatCode>General</c:formatCode>
                <c:ptCount val="10"/>
                <c:pt idx="0">
                  <c:v>49.273344000000009</c:v>
                </c:pt>
                <c:pt idx="1">
                  <c:v>49.273344000000009</c:v>
                </c:pt>
                <c:pt idx="2">
                  <c:v>106.39309999999999</c:v>
                </c:pt>
                <c:pt idx="3">
                  <c:v>155.37319200000002</c:v>
                </c:pt>
                <c:pt idx="4">
                  <c:v>400.37263200000001</c:v>
                </c:pt>
                <c:pt idx="5">
                  <c:v>292.99327199999999</c:v>
                </c:pt>
                <c:pt idx="6">
                  <c:v>620.928</c:v>
                </c:pt>
                <c:pt idx="7">
                  <c:v>771.43247999999994</c:v>
                </c:pt>
                <c:pt idx="8">
                  <c:v>1613.4388760000002</c:v>
                </c:pt>
                <c:pt idx="9">
                  <c:v>1169.10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1E4A-4E5B-AFF0-70544CA074E2}"/>
            </c:ext>
          </c:extLst>
        </c:ser>
        <c:ser>
          <c:idx val="17"/>
          <c:order val="13"/>
          <c:tx>
            <c:strRef>
              <c:f>Sheet1!$A$50</c:f>
              <c:strCache>
                <c:ptCount val="1"/>
                <c:pt idx="0">
                  <c:v>PD-1-CRT_3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0:$P$50</c:f>
              <c:numCache>
                <c:formatCode>General</c:formatCode>
                <c:ptCount val="10"/>
                <c:pt idx="0">
                  <c:v>32.360211999999997</c:v>
                </c:pt>
                <c:pt idx="1">
                  <c:v>32.36021199999999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1E4A-4E5B-AFF0-70544CA074E2}"/>
            </c:ext>
          </c:extLst>
        </c:ser>
        <c:ser>
          <c:idx val="18"/>
          <c:order val="14"/>
          <c:tx>
            <c:strRef>
              <c:f>Sheet1!$A$51</c:f>
              <c:strCache>
                <c:ptCount val="1"/>
                <c:pt idx="0">
                  <c:v>PD-1-CRT_4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1:$P$51</c:f>
              <c:numCache>
                <c:formatCode>General</c:formatCode>
                <c:ptCount val="10"/>
                <c:pt idx="0">
                  <c:v>54.906700000000008</c:v>
                </c:pt>
                <c:pt idx="1">
                  <c:v>54.906700000000008</c:v>
                </c:pt>
                <c:pt idx="2">
                  <c:v>74.147228999999996</c:v>
                </c:pt>
                <c:pt idx="3">
                  <c:v>164.21702400000001</c:v>
                </c:pt>
                <c:pt idx="4">
                  <c:v>352.56707899999998</c:v>
                </c:pt>
                <c:pt idx="5">
                  <c:v>405.40953600000006</c:v>
                </c:pt>
                <c:pt idx="6">
                  <c:v>322.94295</c:v>
                </c:pt>
                <c:pt idx="7">
                  <c:v>1050.4617499999999</c:v>
                </c:pt>
                <c:pt idx="8">
                  <c:v>1650.4410960000002</c:v>
                </c:pt>
                <c:pt idx="9">
                  <c:v>2405.1301415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1E4A-4E5B-AFF0-70544CA074E2}"/>
            </c:ext>
          </c:extLst>
        </c:ser>
        <c:ser>
          <c:idx val="19"/>
          <c:order val="15"/>
          <c:tx>
            <c:strRef>
              <c:f>Sheet1!$A$52</c:f>
              <c:strCache>
                <c:ptCount val="1"/>
                <c:pt idx="0">
                  <c:v>PD-1-CRT_5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2:$P$52</c:f>
              <c:numCache>
                <c:formatCode>General</c:formatCode>
                <c:ptCount val="10"/>
                <c:pt idx="0">
                  <c:v>26.521287999999998</c:v>
                </c:pt>
                <c:pt idx="1">
                  <c:v>26.501904</c:v>
                </c:pt>
                <c:pt idx="2">
                  <c:v>33.022835999999991</c:v>
                </c:pt>
                <c:pt idx="3">
                  <c:v>74.028527999999994</c:v>
                </c:pt>
                <c:pt idx="4">
                  <c:v>365.27263249999999</c:v>
                </c:pt>
                <c:pt idx="5">
                  <c:v>555.01205599999992</c:v>
                </c:pt>
                <c:pt idx="6">
                  <c:v>431.65089999999998</c:v>
                </c:pt>
                <c:pt idx="7">
                  <c:v>1223.379542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E4A-4E5B-AFF0-70544CA074E2}"/>
            </c:ext>
          </c:extLst>
        </c:ser>
        <c:ser>
          <c:idx val="20"/>
          <c:order val="16"/>
          <c:tx>
            <c:strRef>
              <c:f>Sheet1!$A$53</c:f>
              <c:strCache>
                <c:ptCount val="1"/>
                <c:pt idx="0">
                  <c:v>PD-1-CRT_6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3:$P$53</c:f>
              <c:numCache>
                <c:formatCode>General</c:formatCode>
                <c:ptCount val="10"/>
                <c:pt idx="0">
                  <c:v>40.297499999999999</c:v>
                </c:pt>
                <c:pt idx="1">
                  <c:v>47.903359999999999</c:v>
                </c:pt>
                <c:pt idx="2">
                  <c:v>63.416281500000011</c:v>
                </c:pt>
                <c:pt idx="3">
                  <c:v>216.64018399999998</c:v>
                </c:pt>
                <c:pt idx="4">
                  <c:v>409.01567649999993</c:v>
                </c:pt>
                <c:pt idx="5">
                  <c:v>558.96750000000009</c:v>
                </c:pt>
                <c:pt idx="6">
                  <c:v>465.24700799999994</c:v>
                </c:pt>
                <c:pt idx="7">
                  <c:v>1218.155808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1E4A-4E5B-AFF0-70544CA074E2}"/>
            </c:ext>
          </c:extLst>
        </c:ser>
        <c:ser>
          <c:idx val="21"/>
          <c:order val="17"/>
          <c:tx>
            <c:strRef>
              <c:f>Sheet1!$A$54</c:f>
              <c:strCache>
                <c:ptCount val="1"/>
                <c:pt idx="0">
                  <c:v>PD-1-CRT_7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4:$P$54</c:f>
              <c:numCache>
                <c:formatCode>General</c:formatCode>
                <c:ptCount val="10"/>
                <c:pt idx="0">
                  <c:v>56.271575499999997</c:v>
                </c:pt>
                <c:pt idx="1">
                  <c:v>64.683937999999998</c:v>
                </c:pt>
                <c:pt idx="2">
                  <c:v>65.482514500000008</c:v>
                </c:pt>
                <c:pt idx="3">
                  <c:v>214.5182935</c:v>
                </c:pt>
                <c:pt idx="4">
                  <c:v>457.26183200000008</c:v>
                </c:pt>
                <c:pt idx="5">
                  <c:v>570.39206400000012</c:v>
                </c:pt>
                <c:pt idx="6">
                  <c:v>505.9611144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E4A-4E5B-AFF0-70544CA074E2}"/>
            </c:ext>
          </c:extLst>
        </c:ser>
        <c:ser>
          <c:idx val="22"/>
          <c:order val="18"/>
          <c:tx>
            <c:strRef>
              <c:f>Sheet1!$A$55</c:f>
              <c:strCache>
                <c:ptCount val="1"/>
                <c:pt idx="0">
                  <c:v>PD-1-CRT_8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5:$P$55</c:f>
              <c:numCache>
                <c:formatCode>General</c:formatCode>
                <c:ptCount val="10"/>
                <c:pt idx="0">
                  <c:v>45.355487999999994</c:v>
                </c:pt>
                <c:pt idx="1">
                  <c:v>52.809288999999993</c:v>
                </c:pt>
                <c:pt idx="2">
                  <c:v>99.149947999999981</c:v>
                </c:pt>
                <c:pt idx="3">
                  <c:v>497.30342400000001</c:v>
                </c:pt>
                <c:pt idx="4">
                  <c:v>734.87571300000013</c:v>
                </c:pt>
                <c:pt idx="5">
                  <c:v>1104.1964760000001</c:v>
                </c:pt>
                <c:pt idx="6">
                  <c:v>1610.6068239999997</c:v>
                </c:pt>
                <c:pt idx="7">
                  <c:v>3908.9032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1E4A-4E5B-AFF0-70544CA074E2}"/>
            </c:ext>
          </c:extLst>
        </c:ser>
        <c:ser>
          <c:idx val="23"/>
          <c:order val="19"/>
          <c:tx>
            <c:strRef>
              <c:f>Sheet1!$A$56</c:f>
              <c:strCache>
                <c:ptCount val="1"/>
                <c:pt idx="0">
                  <c:v>PD-1-CRT_9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56:$P$56</c:f>
              <c:numCache>
                <c:formatCode>General</c:formatCode>
                <c:ptCount val="10"/>
                <c:pt idx="0">
                  <c:v>96.894962499999977</c:v>
                </c:pt>
                <c:pt idx="1">
                  <c:v>90.313935999999998</c:v>
                </c:pt>
                <c:pt idx="2">
                  <c:v>103.06338799999999</c:v>
                </c:pt>
                <c:pt idx="3">
                  <c:v>90.979968</c:v>
                </c:pt>
                <c:pt idx="4">
                  <c:v>56.8967285000000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E4A-4E5B-AFF0-70544CA074E2}"/>
            </c:ext>
          </c:extLst>
        </c:ser>
        <c:ser>
          <c:idx val="0"/>
          <c:order val="20"/>
          <c:tx>
            <c:strRef>
              <c:f>Sheet1!$A$39</c:f>
              <c:strCache>
                <c:ptCount val="1"/>
                <c:pt idx="0">
                  <c:v>PD-1_6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39:$P$39</c:f>
              <c:numCache>
                <c:formatCode>General</c:formatCode>
                <c:ptCount val="10"/>
                <c:pt idx="0">
                  <c:v>85.625396500000008</c:v>
                </c:pt>
                <c:pt idx="1">
                  <c:v>463.22279999999995</c:v>
                </c:pt>
                <c:pt idx="2">
                  <c:v>1223.1202500000002</c:v>
                </c:pt>
                <c:pt idx="3">
                  <c:v>1987.74</c:v>
                </c:pt>
                <c:pt idx="4">
                  <c:v>2342.7613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1E4A-4E5B-AFF0-70544CA074E2}"/>
            </c:ext>
          </c:extLst>
        </c:ser>
        <c:ser>
          <c:idx val="4"/>
          <c:order val="21"/>
          <c:tx>
            <c:strRef>
              <c:f>Sheet1!$A$40</c:f>
              <c:strCache>
                <c:ptCount val="1"/>
                <c:pt idx="0">
                  <c:v>PD-1_7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0:$P$40</c:f>
              <c:numCache>
                <c:formatCode>General</c:formatCode>
                <c:ptCount val="10"/>
                <c:pt idx="0">
                  <c:v>22.303674000000001</c:v>
                </c:pt>
                <c:pt idx="1">
                  <c:v>41.817599999999999</c:v>
                </c:pt>
                <c:pt idx="2">
                  <c:v>607.30616250000003</c:v>
                </c:pt>
                <c:pt idx="3">
                  <c:v>317.72326750000002</c:v>
                </c:pt>
                <c:pt idx="4">
                  <c:v>572.12174000000005</c:v>
                </c:pt>
                <c:pt idx="5">
                  <c:v>789.72155850000001</c:v>
                </c:pt>
                <c:pt idx="6">
                  <c:v>811.7691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E4A-4E5B-AFF0-70544CA074E2}"/>
            </c:ext>
          </c:extLst>
        </c:ser>
        <c:ser>
          <c:idx val="13"/>
          <c:order val="22"/>
          <c:tx>
            <c:strRef>
              <c:f>Sheet1!$A$41</c:f>
              <c:strCache>
                <c:ptCount val="1"/>
                <c:pt idx="0">
                  <c:v>PD-1_8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1:$P$41</c:f>
              <c:numCache>
                <c:formatCode>General</c:formatCode>
                <c:ptCount val="10"/>
                <c:pt idx="0">
                  <c:v>103.060524</c:v>
                </c:pt>
                <c:pt idx="1">
                  <c:v>886.00780799999995</c:v>
                </c:pt>
                <c:pt idx="2">
                  <c:v>1198.54</c:v>
                </c:pt>
                <c:pt idx="3">
                  <c:v>1488.5800920000001</c:v>
                </c:pt>
                <c:pt idx="4">
                  <c:v>2380.927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1E4A-4E5B-AFF0-70544CA074E2}"/>
            </c:ext>
          </c:extLst>
        </c:ser>
        <c:ser>
          <c:idx val="14"/>
          <c:order val="23"/>
          <c:tx>
            <c:strRef>
              <c:f>Sheet1!$A$42</c:f>
              <c:strCache>
                <c:ptCount val="1"/>
                <c:pt idx="0">
                  <c:v>PD-1_9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42:$P$42</c:f>
              <c:numCache>
                <c:formatCode>General</c:formatCode>
                <c:ptCount val="10"/>
                <c:pt idx="0">
                  <c:v>78.876720000000006</c:v>
                </c:pt>
                <c:pt idx="1">
                  <c:v>828.32950200000005</c:v>
                </c:pt>
                <c:pt idx="2">
                  <c:v>1484.7449999999999</c:v>
                </c:pt>
                <c:pt idx="3">
                  <c:v>2465.412911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1E4A-4E5B-AFF0-70544CA074E2}"/>
            </c:ext>
          </c:extLst>
        </c:ser>
        <c:ser>
          <c:idx val="24"/>
          <c:order val="24"/>
          <c:tx>
            <c:strRef>
              <c:f>Sheet1!$A$32</c:f>
              <c:strCache>
                <c:ptCount val="1"/>
                <c:pt idx="0">
                  <c:v>Ctrl_4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strLit>
              <c:ptCount val="15"/>
              <c:pt idx="0">
                <c:v>0</c:v>
              </c:pt>
              <c:pt idx="1">
                <c:v>4</c:v>
              </c:pt>
              <c:pt idx="2">
                <c:v>7</c:v>
              </c:pt>
              <c:pt idx="3">
                <c:v>11</c:v>
              </c:pt>
              <c:pt idx="4">
                <c:v>14</c:v>
              </c:pt>
              <c:pt idx="5">
                <c:v>18</c:v>
              </c:pt>
              <c:pt idx="6">
                <c:v>21</c:v>
              </c:pt>
              <c:pt idx="7">
                <c:v>25</c:v>
              </c:pt>
              <c:pt idx="8">
                <c:v>28</c:v>
              </c:pt>
              <c:pt idx="9">
                <c:v>32</c:v>
              </c:pt>
              <c:pt idx="10">
                <c:v>35</c:v>
              </c:pt>
              <c:pt idx="11">
                <c:v>39</c:v>
              </c:pt>
              <c:pt idx="12">
                <c:v>42</c:v>
              </c:pt>
              <c:pt idx="13">
                <c:v>46</c:v>
              </c:pt>
              <c:pt idx="14">
                <c:v>4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Sheet1!$B$32:$F$32</c:f>
              <c:numCache>
                <c:formatCode>General</c:formatCode>
                <c:ptCount val="5"/>
                <c:pt idx="0">
                  <c:v>69.838847999999999</c:v>
                </c:pt>
                <c:pt idx="1">
                  <c:v>392.35918800000002</c:v>
                </c:pt>
                <c:pt idx="2">
                  <c:v>831.42294400000014</c:v>
                </c:pt>
                <c:pt idx="3">
                  <c:v>1375.2879980000002</c:v>
                </c:pt>
                <c:pt idx="4">
                  <c:v>2963.9899245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E4A-4E5B-AFF0-70544CA074E2}"/>
            </c:ext>
          </c:extLst>
        </c:ser>
        <c:ser>
          <c:idx val="25"/>
          <c:order val="25"/>
          <c:tx>
            <c:strRef>
              <c:f>Sheet1!$A$33</c:f>
              <c:strCache>
                <c:ptCount val="1"/>
                <c:pt idx="0">
                  <c:v>Ctrl_5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strLit>
              <c:ptCount val="15"/>
              <c:pt idx="0">
                <c:v>0</c:v>
              </c:pt>
              <c:pt idx="1">
                <c:v>4</c:v>
              </c:pt>
              <c:pt idx="2">
                <c:v>7</c:v>
              </c:pt>
              <c:pt idx="3">
                <c:v>11</c:v>
              </c:pt>
              <c:pt idx="4">
                <c:v>14</c:v>
              </c:pt>
              <c:pt idx="5">
                <c:v>18</c:v>
              </c:pt>
              <c:pt idx="6">
                <c:v>21</c:v>
              </c:pt>
              <c:pt idx="7">
                <c:v>25</c:v>
              </c:pt>
              <c:pt idx="8">
                <c:v>28</c:v>
              </c:pt>
              <c:pt idx="9">
                <c:v>32</c:v>
              </c:pt>
              <c:pt idx="10">
                <c:v>35</c:v>
              </c:pt>
              <c:pt idx="11">
                <c:v>39</c:v>
              </c:pt>
              <c:pt idx="12">
                <c:v>42</c:v>
              </c:pt>
              <c:pt idx="13">
                <c:v>46</c:v>
              </c:pt>
              <c:pt idx="14">
                <c:v>4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Sheet1!$B$33:$E$33</c:f>
              <c:numCache>
                <c:formatCode>General</c:formatCode>
                <c:ptCount val="4"/>
                <c:pt idx="0">
                  <c:v>86.096575999999999</c:v>
                </c:pt>
                <c:pt idx="1">
                  <c:v>765.04925000000014</c:v>
                </c:pt>
                <c:pt idx="2">
                  <c:v>1810.6828479999999</c:v>
                </c:pt>
                <c:pt idx="3">
                  <c:v>2401.152074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1E4A-4E5B-AFF0-70544CA074E2}"/>
            </c:ext>
          </c:extLst>
        </c:ser>
        <c:ser>
          <c:idx val="26"/>
          <c:order val="26"/>
          <c:tx>
            <c:strRef>
              <c:f>Sheet1!$A$46</c:f>
              <c:strCache>
                <c:ptCount val="1"/>
                <c:pt idx="0">
                  <c:v>CRT_4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strLit>
              <c:ptCount val="15"/>
              <c:pt idx="0">
                <c:v>0</c:v>
              </c:pt>
              <c:pt idx="1">
                <c:v>4</c:v>
              </c:pt>
              <c:pt idx="2">
                <c:v>7</c:v>
              </c:pt>
              <c:pt idx="3">
                <c:v>11</c:v>
              </c:pt>
              <c:pt idx="4">
                <c:v>14</c:v>
              </c:pt>
              <c:pt idx="5">
                <c:v>18</c:v>
              </c:pt>
              <c:pt idx="6">
                <c:v>21</c:v>
              </c:pt>
              <c:pt idx="7">
                <c:v>25</c:v>
              </c:pt>
              <c:pt idx="8">
                <c:v>28</c:v>
              </c:pt>
              <c:pt idx="9">
                <c:v>32</c:v>
              </c:pt>
              <c:pt idx="10">
                <c:v>35</c:v>
              </c:pt>
              <c:pt idx="11">
                <c:v>39</c:v>
              </c:pt>
              <c:pt idx="12">
                <c:v>42</c:v>
              </c:pt>
              <c:pt idx="13">
                <c:v>46</c:v>
              </c:pt>
              <c:pt idx="14">
                <c:v>4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Sheet1!$B$46:$F$46</c:f>
              <c:numCache>
                <c:formatCode>General</c:formatCode>
                <c:ptCount val="5"/>
                <c:pt idx="0">
                  <c:v>45.446389999999994</c:v>
                </c:pt>
                <c:pt idx="1">
                  <c:v>185.36127500000003</c:v>
                </c:pt>
                <c:pt idx="2">
                  <c:v>687.94822800000009</c:v>
                </c:pt>
                <c:pt idx="3">
                  <c:v>1555.3427120000001</c:v>
                </c:pt>
                <c:pt idx="4">
                  <c:v>1786.5792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1E4A-4E5B-AFF0-70544CA074E2}"/>
            </c:ext>
          </c:extLst>
        </c:ser>
        <c:ser>
          <c:idx val="27"/>
          <c:order val="27"/>
          <c:tx>
            <c:strRef>
              <c:f>Sheet1!$A$47</c:f>
              <c:strCache>
                <c:ptCount val="1"/>
                <c:pt idx="0">
                  <c:v>CRT_5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strLit>
              <c:ptCount val="15"/>
              <c:pt idx="0">
                <c:v>0</c:v>
              </c:pt>
              <c:pt idx="1">
                <c:v>4</c:v>
              </c:pt>
              <c:pt idx="2">
                <c:v>7</c:v>
              </c:pt>
              <c:pt idx="3">
                <c:v>11</c:v>
              </c:pt>
              <c:pt idx="4">
                <c:v>14</c:v>
              </c:pt>
              <c:pt idx="5">
                <c:v>18</c:v>
              </c:pt>
              <c:pt idx="6">
                <c:v>21</c:v>
              </c:pt>
              <c:pt idx="7">
                <c:v>25</c:v>
              </c:pt>
              <c:pt idx="8">
                <c:v>28</c:v>
              </c:pt>
              <c:pt idx="9">
                <c:v>32</c:v>
              </c:pt>
              <c:pt idx="10">
                <c:v>35</c:v>
              </c:pt>
              <c:pt idx="11">
                <c:v>39</c:v>
              </c:pt>
              <c:pt idx="12">
                <c:v>42</c:v>
              </c:pt>
              <c:pt idx="13">
                <c:v>46</c:v>
              </c:pt>
              <c:pt idx="14">
                <c:v>4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Sheet1!$B$47:$G$47</c:f>
              <c:numCache>
                <c:formatCode>General</c:formatCode>
                <c:ptCount val="6"/>
                <c:pt idx="0">
                  <c:v>41.132731500000006</c:v>
                </c:pt>
                <c:pt idx="1">
                  <c:v>254.36392799999999</c:v>
                </c:pt>
                <c:pt idx="2">
                  <c:v>377.62918399999995</c:v>
                </c:pt>
                <c:pt idx="3">
                  <c:v>1015.4668180000001</c:v>
                </c:pt>
                <c:pt idx="4">
                  <c:v>1887.0507874999996</c:v>
                </c:pt>
                <c:pt idx="5">
                  <c:v>2434.85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E4A-4E5B-AFF0-70544CA074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1953675832"/>
        <c:axId val="1823764680"/>
      </c:lineChart>
      <c:catAx>
        <c:axId val="-19536758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823764680"/>
        <c:crossesAt val="0"/>
        <c:auto val="1"/>
        <c:lblAlgn val="ctr"/>
        <c:lblOffset val="0"/>
        <c:tickLblSkip val="2"/>
        <c:tickMarkSkip val="2"/>
        <c:noMultiLvlLbl val="0"/>
      </c:catAx>
      <c:valAx>
        <c:axId val="1823764680"/>
        <c:scaling>
          <c:orientation val="minMax"/>
          <c:max val="45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1953675832"/>
        <c:crossesAt val="1"/>
        <c:crossBetween val="midCat"/>
        <c:majorUnit val="10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lineChart>
        <c:grouping val="standard"/>
        <c:varyColors val="0"/>
        <c:ser>
          <c:idx val="10"/>
          <c:order val="0"/>
          <c:tx>
            <c:strRef>
              <c:f>Sheet1!$A$78</c:f>
              <c:strCache>
                <c:ptCount val="1"/>
                <c:pt idx="0">
                  <c:v>CRT_1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78:$P$78</c:f>
              <c:numCache>
                <c:formatCode>General</c:formatCode>
                <c:ptCount val="10"/>
                <c:pt idx="0">
                  <c:v>274.52480000000003</c:v>
                </c:pt>
                <c:pt idx="1">
                  <c:v>885.2616680000001</c:v>
                </c:pt>
                <c:pt idx="2">
                  <c:v>1540.8361025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37F-40D8-8008-055CC43CA03A}"/>
            </c:ext>
          </c:extLst>
        </c:ser>
        <c:ser>
          <c:idx val="11"/>
          <c:order val="1"/>
          <c:tx>
            <c:strRef>
              <c:f>Sheet1!$A$79</c:f>
              <c:strCache>
                <c:ptCount val="1"/>
                <c:pt idx="0">
                  <c:v>CRT_2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79:$P$79</c:f>
              <c:numCache>
                <c:formatCode>General</c:formatCode>
                <c:ptCount val="10"/>
                <c:pt idx="0">
                  <c:v>210.822048</c:v>
                </c:pt>
                <c:pt idx="1">
                  <c:v>683.75534400000004</c:v>
                </c:pt>
                <c:pt idx="2">
                  <c:v>1243.904904</c:v>
                </c:pt>
                <c:pt idx="3">
                  <c:v>1268.7256554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37F-40D8-8008-055CC43CA03A}"/>
            </c:ext>
          </c:extLst>
        </c:ser>
        <c:ser>
          <c:idx val="12"/>
          <c:order val="2"/>
          <c:tx>
            <c:strRef>
              <c:f>Sheet1!$A$80</c:f>
              <c:strCache>
                <c:ptCount val="1"/>
                <c:pt idx="0">
                  <c:v>CRT_3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0:$P$80</c:f>
              <c:numCache>
                <c:formatCode>General</c:formatCode>
                <c:ptCount val="10"/>
                <c:pt idx="0">
                  <c:v>286.6162635</c:v>
                </c:pt>
                <c:pt idx="1">
                  <c:v>1144.566016</c:v>
                </c:pt>
                <c:pt idx="2">
                  <c:v>1862.026656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37F-40D8-8008-055CC43CA03A}"/>
            </c:ext>
          </c:extLst>
        </c:ser>
        <c:ser>
          <c:idx val="15"/>
          <c:order val="3"/>
          <c:tx>
            <c:strRef>
              <c:f>Sheet1!$A$83</c:f>
              <c:strCache>
                <c:ptCount val="1"/>
                <c:pt idx="0">
                  <c:v>PD-1-CRT_1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3:$P$83</c:f>
              <c:numCache>
                <c:formatCode>General</c:formatCode>
                <c:ptCount val="10"/>
                <c:pt idx="0">
                  <c:v>184.4030875</c:v>
                </c:pt>
                <c:pt idx="1">
                  <c:v>284.95354799999996</c:v>
                </c:pt>
                <c:pt idx="2">
                  <c:v>383.85601350000002</c:v>
                </c:pt>
                <c:pt idx="3">
                  <c:v>904.12656250000009</c:v>
                </c:pt>
                <c:pt idx="4">
                  <c:v>879.931962</c:v>
                </c:pt>
                <c:pt idx="5">
                  <c:v>1016.1123890000001</c:v>
                </c:pt>
                <c:pt idx="6">
                  <c:v>1770.6033360000001</c:v>
                </c:pt>
                <c:pt idx="7">
                  <c:v>1770.6033360000001</c:v>
                </c:pt>
                <c:pt idx="8">
                  <c:v>1996.132607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37F-40D8-8008-055CC43CA03A}"/>
            </c:ext>
          </c:extLst>
        </c:ser>
        <c:ser>
          <c:idx val="16"/>
          <c:order val="4"/>
          <c:tx>
            <c:strRef>
              <c:f>Sheet1!$A$84</c:f>
              <c:strCache>
                <c:ptCount val="1"/>
                <c:pt idx="0">
                  <c:v>PD-1-CRT_2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4:$P$84</c:f>
              <c:numCache>
                <c:formatCode>General</c:formatCode>
                <c:ptCount val="10"/>
                <c:pt idx="0">
                  <c:v>140.10468750000001</c:v>
                </c:pt>
                <c:pt idx="1">
                  <c:v>140.10468750000001</c:v>
                </c:pt>
                <c:pt idx="2">
                  <c:v>184.05554400000003</c:v>
                </c:pt>
                <c:pt idx="3">
                  <c:v>405.27045000000004</c:v>
                </c:pt>
                <c:pt idx="4">
                  <c:v>484.10380800000007</c:v>
                </c:pt>
                <c:pt idx="5">
                  <c:v>584.52468749999991</c:v>
                </c:pt>
                <c:pt idx="6">
                  <c:v>992.37327199999993</c:v>
                </c:pt>
                <c:pt idx="7">
                  <c:v>1219.3341439999999</c:v>
                </c:pt>
                <c:pt idx="8">
                  <c:v>1322.8345839999999</c:v>
                </c:pt>
                <c:pt idx="9">
                  <c:v>1969.996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37F-40D8-8008-055CC43CA03A}"/>
            </c:ext>
          </c:extLst>
        </c:ser>
        <c:ser>
          <c:idx val="17"/>
          <c:order val="5"/>
          <c:tx>
            <c:strRef>
              <c:f>Sheet1!$A$85</c:f>
              <c:strCache>
                <c:ptCount val="1"/>
                <c:pt idx="0">
                  <c:v>PD-1-CRT_3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5:$P$8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437F-40D8-8008-055CC43CA03A}"/>
            </c:ext>
          </c:extLst>
        </c:ser>
        <c:ser>
          <c:idx val="18"/>
          <c:order val="6"/>
          <c:tx>
            <c:strRef>
              <c:f>Sheet1!$A$86</c:f>
              <c:strCache>
                <c:ptCount val="1"/>
                <c:pt idx="0">
                  <c:v>PD-1-CRT_4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6:$P$86</c:f>
              <c:numCache>
                <c:formatCode>General</c:formatCode>
                <c:ptCount val="10"/>
                <c:pt idx="0">
                  <c:v>168.550543</c:v>
                </c:pt>
                <c:pt idx="1">
                  <c:v>168.550543</c:v>
                </c:pt>
                <c:pt idx="2">
                  <c:v>247.4139055</c:v>
                </c:pt>
                <c:pt idx="3">
                  <c:v>320.60160000000002</c:v>
                </c:pt>
                <c:pt idx="4">
                  <c:v>602.10309600000005</c:v>
                </c:pt>
                <c:pt idx="5">
                  <c:v>657.04820900000004</c:v>
                </c:pt>
                <c:pt idx="6">
                  <c:v>1210.2108030000002</c:v>
                </c:pt>
                <c:pt idx="7">
                  <c:v>1602.9103</c:v>
                </c:pt>
                <c:pt idx="8">
                  <c:v>1697.3621264999997</c:v>
                </c:pt>
                <c:pt idx="9">
                  <c:v>3926.6926405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437F-40D8-8008-055CC43CA03A}"/>
            </c:ext>
          </c:extLst>
        </c:ser>
        <c:ser>
          <c:idx val="19"/>
          <c:order val="7"/>
          <c:tx>
            <c:strRef>
              <c:f>Sheet1!$A$87</c:f>
              <c:strCache>
                <c:ptCount val="1"/>
                <c:pt idx="0">
                  <c:v>PD-1-CRT_5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7:$P$87</c:f>
              <c:numCache>
                <c:formatCode>General</c:formatCode>
                <c:ptCount val="10"/>
                <c:pt idx="0">
                  <c:v>206.32449600000004</c:v>
                </c:pt>
                <c:pt idx="1">
                  <c:v>730.154898</c:v>
                </c:pt>
                <c:pt idx="2">
                  <c:v>757.53160199999991</c:v>
                </c:pt>
                <c:pt idx="3">
                  <c:v>835.46803199999999</c:v>
                </c:pt>
                <c:pt idx="4">
                  <c:v>1328.3520880000001</c:v>
                </c:pt>
                <c:pt idx="5">
                  <c:v>1655.0691870000003</c:v>
                </c:pt>
                <c:pt idx="6">
                  <c:v>1567.5687499999999</c:v>
                </c:pt>
                <c:pt idx="7">
                  <c:v>1891.445318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437F-40D8-8008-055CC43CA03A}"/>
            </c:ext>
          </c:extLst>
        </c:ser>
        <c:ser>
          <c:idx val="20"/>
          <c:order val="8"/>
          <c:tx>
            <c:strRef>
              <c:f>Sheet1!$A$88</c:f>
              <c:strCache>
                <c:ptCount val="1"/>
                <c:pt idx="0">
                  <c:v>PD-1-CRT_6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8:$P$88</c:f>
              <c:numCache>
                <c:formatCode>General</c:formatCode>
                <c:ptCount val="10"/>
                <c:pt idx="0">
                  <c:v>248.62982400000001</c:v>
                </c:pt>
                <c:pt idx="1">
                  <c:v>382.53971250000006</c:v>
                </c:pt>
                <c:pt idx="2">
                  <c:v>330.56387199999989</c:v>
                </c:pt>
                <c:pt idx="3">
                  <c:v>575.61840000000007</c:v>
                </c:pt>
                <c:pt idx="4">
                  <c:v>996.81236550000017</c:v>
                </c:pt>
                <c:pt idx="5">
                  <c:v>1383.8400000000001</c:v>
                </c:pt>
                <c:pt idx="6">
                  <c:v>1028.152278</c:v>
                </c:pt>
                <c:pt idx="7">
                  <c:v>1071.692775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437F-40D8-8008-055CC43CA03A}"/>
            </c:ext>
          </c:extLst>
        </c:ser>
        <c:ser>
          <c:idx val="21"/>
          <c:order val="9"/>
          <c:tx>
            <c:strRef>
              <c:f>Sheet1!$A$89</c:f>
              <c:strCache>
                <c:ptCount val="1"/>
                <c:pt idx="0">
                  <c:v>PD-1-CRT_7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89:$P$89</c:f>
              <c:numCache>
                <c:formatCode>General</c:formatCode>
                <c:ptCount val="10"/>
                <c:pt idx="0">
                  <c:v>193.098816</c:v>
                </c:pt>
                <c:pt idx="1">
                  <c:v>246.66873399999997</c:v>
                </c:pt>
                <c:pt idx="2">
                  <c:v>430.56435199999993</c:v>
                </c:pt>
                <c:pt idx="3">
                  <c:v>478.31697899999995</c:v>
                </c:pt>
                <c:pt idx="4">
                  <c:v>751.68899999999996</c:v>
                </c:pt>
                <c:pt idx="5">
                  <c:v>1087.4124000000002</c:v>
                </c:pt>
                <c:pt idx="6">
                  <c:v>1140.099116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437F-40D8-8008-055CC43CA03A}"/>
            </c:ext>
          </c:extLst>
        </c:ser>
        <c:ser>
          <c:idx val="22"/>
          <c:order val="10"/>
          <c:tx>
            <c:strRef>
              <c:f>Sheet1!$A$90</c:f>
              <c:strCache>
                <c:ptCount val="1"/>
                <c:pt idx="0">
                  <c:v>PD-1-CRT_8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90:$P$90</c:f>
              <c:numCache>
                <c:formatCode>General</c:formatCode>
                <c:ptCount val="10"/>
                <c:pt idx="0">
                  <c:v>167.58021150000002</c:v>
                </c:pt>
                <c:pt idx="1">
                  <c:v>274.15271700000005</c:v>
                </c:pt>
                <c:pt idx="2">
                  <c:v>348.54262399999988</c:v>
                </c:pt>
                <c:pt idx="3">
                  <c:v>560.78615949999994</c:v>
                </c:pt>
                <c:pt idx="4">
                  <c:v>909.73409800000013</c:v>
                </c:pt>
                <c:pt idx="5">
                  <c:v>1686.284766</c:v>
                </c:pt>
                <c:pt idx="6">
                  <c:v>1327.1040000000003</c:v>
                </c:pt>
                <c:pt idx="7">
                  <c:v>3673.176965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437F-40D8-8008-055CC43CA03A}"/>
            </c:ext>
          </c:extLst>
        </c:ser>
        <c:ser>
          <c:idx val="23"/>
          <c:order val="11"/>
          <c:tx>
            <c:strRef>
              <c:f>Sheet1!$A$91</c:f>
              <c:strCache>
                <c:ptCount val="1"/>
                <c:pt idx="0">
                  <c:v>PD-1-CRT_9</c:v>
                </c:pt>
              </c:strCache>
            </c:strRef>
          </c:tx>
          <c:spPr>
            <a:ln>
              <a:solidFill>
                <a:srgbClr val="0000FF"/>
              </a:solidFill>
            </a:ln>
          </c:spPr>
          <c:marker>
            <c:symbol val="none"/>
          </c:marker>
          <c:cat>
            <c:numRef>
              <c:f>Sheet1!$B$2:$P$2</c:f>
              <c:numCache>
                <c:formatCode>General</c:formatCode>
                <c:ptCount val="10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</c:numCache>
            </c:numRef>
          </c:cat>
          <c:val>
            <c:numRef>
              <c:f>Sheet1!$B$91:$P$91</c:f>
              <c:numCache>
                <c:formatCode>General</c:formatCode>
                <c:ptCount val="10"/>
                <c:pt idx="0">
                  <c:v>286.9280955000001</c:v>
                </c:pt>
                <c:pt idx="1">
                  <c:v>452.93643749999995</c:v>
                </c:pt>
                <c:pt idx="2">
                  <c:v>402.17710399999999</c:v>
                </c:pt>
                <c:pt idx="3">
                  <c:v>444.92904400000009</c:v>
                </c:pt>
                <c:pt idx="4">
                  <c:v>485.028486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437F-40D8-8008-055CC43CA03A}"/>
            </c:ext>
          </c:extLst>
        </c:ser>
        <c:ser>
          <c:idx val="0"/>
          <c:order val="12"/>
          <c:tx>
            <c:strRef>
              <c:f>Sheet1!$A$81</c:f>
              <c:strCache>
                <c:ptCount val="1"/>
                <c:pt idx="0">
                  <c:v>CRT_4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strLit>
              <c:ptCount val="15"/>
              <c:pt idx="0">
                <c:v>0</c:v>
              </c:pt>
              <c:pt idx="1">
                <c:v>4</c:v>
              </c:pt>
              <c:pt idx="2">
                <c:v>7</c:v>
              </c:pt>
              <c:pt idx="3">
                <c:v>11</c:v>
              </c:pt>
              <c:pt idx="4">
                <c:v>14</c:v>
              </c:pt>
              <c:pt idx="5">
                <c:v>18</c:v>
              </c:pt>
              <c:pt idx="6">
                <c:v>21</c:v>
              </c:pt>
              <c:pt idx="7">
                <c:v>25</c:v>
              </c:pt>
              <c:pt idx="8">
                <c:v>28</c:v>
              </c:pt>
              <c:pt idx="9">
                <c:v>32</c:v>
              </c:pt>
              <c:pt idx="10">
                <c:v>35</c:v>
              </c:pt>
              <c:pt idx="11">
                <c:v>39</c:v>
              </c:pt>
              <c:pt idx="12">
                <c:v>42</c:v>
              </c:pt>
              <c:pt idx="13">
                <c:v>46</c:v>
              </c:pt>
              <c:pt idx="14">
                <c:v>4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Sheet1!$B$81:$F$81</c:f>
              <c:numCache>
                <c:formatCode>General</c:formatCode>
                <c:ptCount val="5"/>
                <c:pt idx="0">
                  <c:v>265.88</c:v>
                </c:pt>
                <c:pt idx="1">
                  <c:v>666.94168800000011</c:v>
                </c:pt>
                <c:pt idx="2">
                  <c:v>1336.0031999999999</c:v>
                </c:pt>
                <c:pt idx="3">
                  <c:v>1888.5382679999998</c:v>
                </c:pt>
                <c:pt idx="4">
                  <c:v>2202.1761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437F-40D8-8008-055CC43CA03A}"/>
            </c:ext>
          </c:extLst>
        </c:ser>
        <c:ser>
          <c:idx val="1"/>
          <c:order val="13"/>
          <c:tx>
            <c:strRef>
              <c:f>Sheet1!$A$82</c:f>
              <c:strCache>
                <c:ptCount val="1"/>
                <c:pt idx="0">
                  <c:v>CRT_5</c:v>
                </c:pt>
              </c:strCache>
            </c:strRef>
          </c:tx>
          <c:spPr>
            <a:ln>
              <a:solidFill>
                <a:srgbClr val="FFFF00"/>
              </a:solidFill>
            </a:ln>
          </c:spPr>
          <c:marker>
            <c:symbol val="none"/>
          </c:marker>
          <c:cat>
            <c:strLit>
              <c:ptCount val="15"/>
              <c:pt idx="0">
                <c:v>0</c:v>
              </c:pt>
              <c:pt idx="1">
                <c:v>4</c:v>
              </c:pt>
              <c:pt idx="2">
                <c:v>7</c:v>
              </c:pt>
              <c:pt idx="3">
                <c:v>11</c:v>
              </c:pt>
              <c:pt idx="4">
                <c:v>14</c:v>
              </c:pt>
              <c:pt idx="5">
                <c:v>18</c:v>
              </c:pt>
              <c:pt idx="6">
                <c:v>21</c:v>
              </c:pt>
              <c:pt idx="7">
                <c:v>25</c:v>
              </c:pt>
              <c:pt idx="8">
                <c:v>28</c:v>
              </c:pt>
              <c:pt idx="9">
                <c:v>32</c:v>
              </c:pt>
              <c:pt idx="10">
                <c:v>35</c:v>
              </c:pt>
              <c:pt idx="11">
                <c:v>39</c:v>
              </c:pt>
              <c:pt idx="12">
                <c:v>42</c:v>
              </c:pt>
              <c:pt idx="13">
                <c:v>46</c:v>
              </c:pt>
              <c:pt idx="14">
                <c:v>4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Sheet1!$B$82:$G$82</c:f>
              <c:numCache>
                <c:formatCode>General</c:formatCode>
                <c:ptCount val="6"/>
                <c:pt idx="0">
                  <c:v>28.704374999999999</c:v>
                </c:pt>
                <c:pt idx="1">
                  <c:v>148.78806400000002</c:v>
                </c:pt>
                <c:pt idx="2">
                  <c:v>185.71191099999999</c:v>
                </c:pt>
                <c:pt idx="3">
                  <c:v>453.44812499999995</c:v>
                </c:pt>
                <c:pt idx="4">
                  <c:v>457.52673599999997</c:v>
                </c:pt>
                <c:pt idx="5">
                  <c:v>942.723341999999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437F-40D8-8008-055CC43CA0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62985400"/>
        <c:axId val="1823478872"/>
      </c:lineChart>
      <c:catAx>
        <c:axId val="-2062985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823478872"/>
        <c:crosses val="autoZero"/>
        <c:auto val="0"/>
        <c:lblAlgn val="ctr"/>
        <c:lblOffset val="0"/>
        <c:tickLblSkip val="2"/>
        <c:tickMarkSkip val="2"/>
        <c:noMultiLvlLbl val="0"/>
      </c:catAx>
      <c:valAx>
        <c:axId val="1823478872"/>
        <c:scaling>
          <c:orientation val="minMax"/>
          <c:max val="45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62985400"/>
        <c:crossesAt val="1"/>
        <c:crossBetween val="midCat"/>
        <c:majorUnit val="1000"/>
      </c:valAx>
    </c:plotArea>
    <c:plotVisOnly val="1"/>
    <c:dispBlanksAs val="gap"/>
    <c:showDLblsOverMax val="0"/>
  </c:chart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75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193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099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318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7572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272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406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429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8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238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274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1E1C7-E5C6-4883-BFD6-AC70072E9A6C}" type="datetimeFigureOut">
              <a:rPr kumimoji="1" lang="ja-JP" altLang="en-US" smtClean="0"/>
              <a:t>2021/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56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グループ化 28"/>
          <p:cNvGrpSpPr/>
          <p:nvPr/>
        </p:nvGrpSpPr>
        <p:grpSpPr>
          <a:xfrm>
            <a:off x="3374624" y="828138"/>
            <a:ext cx="3580993" cy="3224363"/>
            <a:chOff x="3374624" y="828138"/>
            <a:chExt cx="3580993" cy="3224363"/>
          </a:xfrm>
        </p:grpSpPr>
        <p:graphicFrame>
          <p:nvGraphicFramePr>
            <p:cNvPr id="3" name="グラフ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13428663"/>
                </p:ext>
              </p:extLst>
            </p:nvPr>
          </p:nvGraphicFramePr>
          <p:xfrm>
            <a:off x="3662483" y="902702"/>
            <a:ext cx="3060000" cy="287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7"/>
            <p:cNvSpPr txBox="1">
              <a:spLocks noChangeArrowheads="1"/>
            </p:cNvSpPr>
            <p:nvPr/>
          </p:nvSpPr>
          <p:spPr bwMode="auto">
            <a:xfrm>
              <a:off x="3999818" y="828138"/>
              <a:ext cx="25207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Non-irradiated 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tumors (right flank)</a:t>
              </a:r>
              <a:endParaRPr lang="ja-JP" altLang="en-US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10"/>
            <p:cNvSpPr txBox="1">
              <a:spLocks noChangeArrowheads="1"/>
            </p:cNvSpPr>
            <p:nvPr/>
          </p:nvSpPr>
          <p:spPr bwMode="auto">
            <a:xfrm>
              <a:off x="4677555" y="3775502"/>
              <a:ext cx="22780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Days after treatment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13"/>
            <p:cNvSpPr txBox="1">
              <a:spLocks noChangeArrowheads="1"/>
            </p:cNvSpPr>
            <p:nvPr/>
          </p:nvSpPr>
          <p:spPr bwMode="auto">
            <a:xfrm rot="16200000">
              <a:off x="2690798" y="1898690"/>
              <a:ext cx="1644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Tumor</a:t>
              </a:r>
              <a:r>
                <a:rPr lang="ja-JP" altLang="en-US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ize</a:t>
              </a:r>
              <a:r>
                <a:rPr lang="ja-JP" altLang="en-US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mm</a:t>
              </a:r>
              <a:r>
                <a:rPr lang="en-US" altLang="ja-JP" sz="1200" baseline="300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3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)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8" name="グループ化 27"/>
          <p:cNvGrpSpPr/>
          <p:nvPr/>
        </p:nvGrpSpPr>
        <p:grpSpPr>
          <a:xfrm>
            <a:off x="28577" y="828138"/>
            <a:ext cx="3306103" cy="3221574"/>
            <a:chOff x="28577" y="828138"/>
            <a:chExt cx="3306103" cy="3221574"/>
          </a:xfrm>
        </p:grpSpPr>
        <p:graphicFrame>
          <p:nvGraphicFramePr>
            <p:cNvPr id="2" name="グラフ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11256659"/>
                </p:ext>
              </p:extLst>
            </p:nvPr>
          </p:nvGraphicFramePr>
          <p:xfrm>
            <a:off x="274680" y="945323"/>
            <a:ext cx="3060000" cy="287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" name="テキスト ボックス 6"/>
            <p:cNvSpPr txBox="1">
              <a:spLocks noChangeArrowheads="1"/>
            </p:cNvSpPr>
            <p:nvPr/>
          </p:nvSpPr>
          <p:spPr bwMode="auto">
            <a:xfrm>
              <a:off x="687810" y="828138"/>
              <a:ext cx="240746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Irradiated 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tumors</a:t>
              </a:r>
              <a:r>
                <a:rPr lang="ja-JP" altLang="en-US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left </a:t>
              </a:r>
              <a:r>
                <a:rPr lang="en-US" altLang="ja-JP" sz="1200" dirty="0" err="1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hindlimb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)</a:t>
              </a:r>
              <a:endParaRPr lang="ja-JP" altLang="en-US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8"/>
            <p:cNvSpPr txBox="1">
              <a:spLocks noChangeArrowheads="1"/>
            </p:cNvSpPr>
            <p:nvPr/>
          </p:nvSpPr>
          <p:spPr bwMode="auto">
            <a:xfrm>
              <a:off x="1371196" y="3772713"/>
              <a:ext cx="1920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Days after treatment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14"/>
            <p:cNvSpPr txBox="1">
              <a:spLocks noChangeArrowheads="1"/>
            </p:cNvSpPr>
            <p:nvPr/>
          </p:nvSpPr>
          <p:spPr bwMode="auto">
            <a:xfrm rot="16200000">
              <a:off x="-656041" y="1949083"/>
              <a:ext cx="164623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Tumor</a:t>
              </a:r>
              <a:r>
                <a:rPr lang="ja-JP" altLang="en-US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ize</a:t>
              </a:r>
              <a:r>
                <a:rPr lang="ja-JP" altLang="en-US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mm</a:t>
              </a:r>
              <a:r>
                <a:rPr lang="en-US" altLang="ja-JP" sz="1200" baseline="300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3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)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7" name="グループ化 26"/>
          <p:cNvGrpSpPr/>
          <p:nvPr/>
        </p:nvGrpSpPr>
        <p:grpSpPr>
          <a:xfrm>
            <a:off x="470356" y="4550004"/>
            <a:ext cx="4722127" cy="1321992"/>
            <a:chOff x="5064127" y="4560889"/>
            <a:chExt cx="4722127" cy="1321992"/>
          </a:xfrm>
        </p:grpSpPr>
        <p:sp>
          <p:nvSpPr>
            <p:cNvPr id="10" name="テキスト ボックス 16"/>
            <p:cNvSpPr txBox="1">
              <a:spLocks noChangeArrowheads="1"/>
            </p:cNvSpPr>
            <p:nvPr/>
          </p:nvSpPr>
          <p:spPr bwMode="auto">
            <a:xfrm>
              <a:off x="6873876" y="4560889"/>
              <a:ext cx="15001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trl (n = 5)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7"/>
            <p:cNvSpPr txBox="1">
              <a:spLocks noChangeArrowheads="1"/>
            </p:cNvSpPr>
            <p:nvPr/>
          </p:nvSpPr>
          <p:spPr bwMode="auto">
            <a:xfrm>
              <a:off x="6873877" y="5259388"/>
              <a:ext cx="227012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R</a:t>
              </a:r>
              <a:r>
                <a:rPr lang="en-US" altLang="ja-JP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T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n = 5) </a:t>
              </a:r>
              <a:endParaRPr lang="ja-JP" altLang="en-US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8"/>
            <p:cNvSpPr txBox="1">
              <a:spLocks noChangeArrowheads="1"/>
            </p:cNvSpPr>
            <p:nvPr/>
          </p:nvSpPr>
          <p:spPr bwMode="auto">
            <a:xfrm>
              <a:off x="6873875" y="4895851"/>
              <a:ext cx="181768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αPD-1 (n = 9)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9"/>
            <p:cNvSpPr txBox="1">
              <a:spLocks noChangeArrowheads="1"/>
            </p:cNvSpPr>
            <p:nvPr/>
          </p:nvSpPr>
          <p:spPr bwMode="auto">
            <a:xfrm>
              <a:off x="6873875" y="5605882"/>
              <a:ext cx="291237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RT/post-irradiation 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αPD-1</a:t>
              </a:r>
              <a:r>
                <a:rPr lang="ja-JP" altLang="en-US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 dirty="0" smtClean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n </a:t>
              </a:r>
              <a:r>
                <a:rPr lang="en-US" altLang="ja-JP" sz="12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= 9)</a:t>
              </a:r>
              <a:endParaRPr lang="ja-JP" altLang="en-US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14" name="直線コネクタ 13"/>
            <p:cNvCxnSpPr/>
            <p:nvPr/>
          </p:nvCxnSpPr>
          <p:spPr>
            <a:xfrm>
              <a:off x="6556376" y="4691062"/>
              <a:ext cx="371476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/>
            <p:cNvCxnSpPr/>
            <p:nvPr/>
          </p:nvCxnSpPr>
          <p:spPr>
            <a:xfrm>
              <a:off x="6556376" y="5373688"/>
              <a:ext cx="371476" cy="0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6556376" y="5035549"/>
              <a:ext cx="371476" cy="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>
              <a:off x="6556376" y="5741988"/>
              <a:ext cx="371476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24"/>
            <p:cNvSpPr txBox="1">
              <a:spLocks noChangeArrowheads="1"/>
            </p:cNvSpPr>
            <p:nvPr/>
          </p:nvSpPr>
          <p:spPr bwMode="auto">
            <a:xfrm>
              <a:off x="5408615" y="5426077"/>
              <a:ext cx="15001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RT</a:t>
              </a:r>
              <a:r>
                <a:rPr lang="ja-JP" altLang="en-US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model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25"/>
            <p:cNvSpPr txBox="1">
              <a:spLocks noChangeArrowheads="1"/>
            </p:cNvSpPr>
            <p:nvPr/>
          </p:nvSpPr>
          <p:spPr bwMode="auto">
            <a:xfrm>
              <a:off x="5064127" y="4725989"/>
              <a:ext cx="19478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kumimoji="1" sz="28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 sz="20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Non-CRT</a:t>
              </a:r>
              <a:r>
                <a:rPr lang="ja-JP" altLang="en-US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model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0" name="直線コネクタ 19"/>
            <p:cNvCxnSpPr/>
            <p:nvPr/>
          </p:nvCxnSpPr>
          <p:spPr>
            <a:xfrm flipH="1">
              <a:off x="6362700" y="4625976"/>
              <a:ext cx="0" cy="4683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/>
            <p:cNvCxnSpPr/>
            <p:nvPr/>
          </p:nvCxnSpPr>
          <p:spPr>
            <a:xfrm flipH="1">
              <a:off x="6362701" y="4627564"/>
              <a:ext cx="539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 flipH="1">
              <a:off x="6362701" y="5092700"/>
              <a:ext cx="539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 flipH="1">
              <a:off x="6362700" y="5316539"/>
              <a:ext cx="0" cy="4683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/>
            <p:cNvCxnSpPr/>
            <p:nvPr/>
          </p:nvCxnSpPr>
          <p:spPr>
            <a:xfrm flipH="1">
              <a:off x="6362701" y="5318125"/>
              <a:ext cx="539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/>
            <p:cNvCxnSpPr/>
            <p:nvPr/>
          </p:nvCxnSpPr>
          <p:spPr>
            <a:xfrm flipH="1">
              <a:off x="6362701" y="5783263"/>
              <a:ext cx="539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テキスト ボックス 34"/>
          <p:cNvSpPr txBox="1">
            <a:spLocks noChangeArrowheads="1"/>
          </p:cNvSpPr>
          <p:nvPr/>
        </p:nvSpPr>
        <p:spPr bwMode="auto">
          <a:xfrm>
            <a:off x="28577" y="22225"/>
            <a:ext cx="3597275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1" b="1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ure S</a:t>
            </a:r>
            <a:r>
              <a:rPr lang="en-US" altLang="ja-JP" sz="1801" b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280667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59</Words>
  <Application>Microsoft Office PowerPoint</Application>
  <PresentationFormat>A4 210 x 297 mm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メイリオ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kushima hiroshi</dc:creator>
  <cp:lastModifiedBy>fukushima hiroshi</cp:lastModifiedBy>
  <cp:revision>14</cp:revision>
  <dcterms:created xsi:type="dcterms:W3CDTF">2020-10-08T10:22:26Z</dcterms:created>
  <dcterms:modified xsi:type="dcterms:W3CDTF">2021-01-02T10:51:24Z</dcterms:modified>
</cp:coreProperties>
</file>